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>
      <p:cViewPr>
        <p:scale>
          <a:sx n="100" d="100"/>
          <a:sy n="100" d="100"/>
        </p:scale>
        <p:origin x="2584" y="-81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F:\paper\&#23004;&#27704;&#29614;\&#24178;&#32454;&#32990;\&#24178;&#32454;&#32990;&#20998;&#21270;&#33008;&#23707;&#31227;&#26893;&#32467;&#26524;\&#25968;&#25454;-&#24178;&#32454;&#32990;&#20998;&#21270;&#33008;&#23707;&#31227;&#26893;&#23545;&#22823;&#40736;&#31958;&#23615;&#30149;&#32958;&#30149;&#30340;&#27835;&#30103;&#20316;&#29992;.xlsx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C$63:$C$66</c:f>
                <c:numCache>
                  <c:formatCode>General</c:formatCode>
                  <c:ptCount val="4"/>
                  <c:pt idx="0">
                    <c:v>0.79</c:v>
                  </c:pt>
                  <c:pt idx="1">
                    <c:v>5.819999999999998</c:v>
                  </c:pt>
                  <c:pt idx="2">
                    <c:v>2.14</c:v>
                  </c:pt>
                  <c:pt idx="3">
                    <c:v>6.74</c:v>
                  </c:pt>
                </c:numCache>
              </c:numRef>
            </c:plus>
            <c:minus>
              <c:numRef>
                <c:f>Sheet1!$C$63:$C$66</c:f>
                <c:numCache>
                  <c:formatCode>General</c:formatCode>
                  <c:ptCount val="4"/>
                  <c:pt idx="0">
                    <c:v>0.79</c:v>
                  </c:pt>
                  <c:pt idx="1">
                    <c:v>5.819999999999998</c:v>
                  </c:pt>
                  <c:pt idx="2">
                    <c:v>2.14</c:v>
                  </c:pt>
                  <c:pt idx="3">
                    <c:v>6.74</c:v>
                  </c:pt>
                </c:numCache>
              </c:numRef>
            </c:minus>
          </c:errBars>
          <c:cat>
            <c:strRef>
              <c:f>Sheet1!$A$63:$A$66</c:f>
              <c:strCache>
                <c:ptCount val="4"/>
                <c:pt idx="0">
                  <c:v>Control</c:v>
                </c:pt>
                <c:pt idx="1">
                  <c:v>Diabetes</c:v>
                </c:pt>
                <c:pt idx="2">
                  <c:v>Progenitors</c:v>
                </c:pt>
                <c:pt idx="3">
                  <c:v>Insulin</c:v>
                </c:pt>
              </c:strCache>
            </c:strRef>
          </c:cat>
          <c:val>
            <c:numRef>
              <c:f>Sheet1!$B$63:$B$66</c:f>
              <c:numCache>
                <c:formatCode>General</c:formatCode>
                <c:ptCount val="4"/>
                <c:pt idx="0">
                  <c:v>5.9</c:v>
                </c:pt>
                <c:pt idx="1">
                  <c:v>21.1</c:v>
                </c:pt>
                <c:pt idx="2">
                  <c:v>9.75</c:v>
                </c:pt>
                <c:pt idx="3">
                  <c:v>23.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8"/>
        <c:axId val="1681972176"/>
        <c:axId val="1642151840"/>
      </c:barChart>
      <c:catAx>
        <c:axId val="16819721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1642151840"/>
        <c:crosses val="autoZero"/>
        <c:auto val="1"/>
        <c:lblAlgn val="ctr"/>
        <c:lblOffset val="100"/>
        <c:noMultiLvlLbl val="0"/>
      </c:catAx>
      <c:valAx>
        <c:axId val="16421518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b="0"/>
                </a:pPr>
                <a:r>
                  <a:rPr lang="en-US" b="0"/>
                  <a:t>Kidney Index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16819721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7937</cdr:x>
      <cdr:y>0.07978</cdr:y>
    </cdr:from>
    <cdr:to>
      <cdr:x>0.5826</cdr:x>
      <cdr:y>0.1900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958862" y="138299"/>
          <a:ext cx="206485" cy="1911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/>
        <a:p xmlns:a="http://schemas.openxmlformats.org/drawingml/2006/main">
          <a:r>
            <a:rPr lang="en-US" altLang="zh-CN" sz="1100" dirty="0"/>
            <a:t>*</a:t>
          </a:r>
          <a:endParaRPr lang="zh-CN" altLang="en-US" sz="1100" dirty="0"/>
        </a:p>
      </cdr:txBody>
    </cdr:sp>
  </cdr:relSizeAnchor>
  <cdr:relSizeAnchor xmlns:cdr="http://schemas.openxmlformats.org/drawingml/2006/chartDrawing">
    <cdr:from>
      <cdr:x>0.63226</cdr:x>
      <cdr:y>0.41065</cdr:y>
    </cdr:from>
    <cdr:to>
      <cdr:x>0.73548</cdr:x>
      <cdr:y>0.52091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493520" y="822960"/>
          <a:ext cx="243840" cy="2209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zh-CN" sz="1100"/>
            <a:t>#</a:t>
          </a:r>
          <a:endParaRPr lang="zh-CN" altLang="en-US" sz="1100"/>
        </a:p>
      </cdr:txBody>
    </cdr:sp>
  </cdr:relSizeAnchor>
  <cdr:relSizeAnchor xmlns:cdr="http://schemas.openxmlformats.org/drawingml/2006/chartDrawing">
    <cdr:from>
      <cdr:x>0.62223</cdr:x>
      <cdr:y>0.28582</cdr:y>
    </cdr:from>
    <cdr:to>
      <cdr:x>0.72546</cdr:x>
      <cdr:y>0.39608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1244614" y="495489"/>
          <a:ext cx="206485" cy="1911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zh-CN" dirty="0" smtClean="0"/>
            <a:t>#</a:t>
          </a:r>
          <a:endParaRPr lang="zh-CN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86E8E-3DE9-4EA3-8902-8DCC1A7800D0}" type="datetimeFigureOut">
              <a:rPr lang="zh-CN" altLang="en-US" smtClean="0"/>
              <a:pPr/>
              <a:t>17/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BC4F07-B651-42A0-AA7E-868480F1C8C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73100" y="3171627"/>
            <a:ext cx="3556000" cy="1644650"/>
            <a:chOff x="1116892" y="2143116"/>
            <a:chExt cx="6622028" cy="28591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428860" y="2143116"/>
              <a:ext cx="5310060" cy="2859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" name="TextBox 3"/>
            <p:cNvSpPr txBox="1"/>
            <p:nvPr/>
          </p:nvSpPr>
          <p:spPr>
            <a:xfrm>
              <a:off x="1451813" y="2214558"/>
              <a:ext cx="1072260" cy="4280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Control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341363" y="3000371"/>
              <a:ext cx="1182710" cy="4280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Diabetes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116892" y="3714754"/>
              <a:ext cx="1445403" cy="4280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Progenitors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517486" y="4500571"/>
              <a:ext cx="1006587" cy="4280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 smtClean="0">
                  <a:latin typeface="Times New Roman" pitchFamily="18" charset="0"/>
                  <a:cs typeface="Times New Roman" pitchFamily="18" charset="0"/>
                </a:rPr>
                <a:t>Insulin</a:t>
              </a:r>
              <a:endParaRPr lang="zh-CN" alt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406650" y="2819403"/>
            <a:ext cx="340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95900" y="281940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标题 1"/>
          <p:cNvSpPr txBox="1">
            <a:spLocks/>
          </p:cNvSpPr>
          <p:nvPr/>
        </p:nvSpPr>
        <p:spPr>
          <a:xfrm>
            <a:off x="2071678" y="6096008"/>
            <a:ext cx="2470161" cy="5921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Supplemental Figure 1</a:t>
            </a:r>
            <a:endParaRPr kumimoji="0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graphicFrame>
        <p:nvGraphicFramePr>
          <p:cNvPr id="12" name="图表 11"/>
          <p:cNvGraphicFramePr/>
          <p:nvPr/>
        </p:nvGraphicFramePr>
        <p:xfrm>
          <a:off x="4184650" y="3171627"/>
          <a:ext cx="2000250" cy="1733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4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Times New Roman</vt:lpstr>
      <vt:lpstr>宋体</vt:lpstr>
      <vt:lpstr>Arial</vt:lpstr>
      <vt:lpstr>Office 主题</vt:lpstr>
      <vt:lpstr>PowerPoint Presentation</vt:lpstr>
    </vt:vector>
  </TitlesOfParts>
  <Company>微软中国</Company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张文健</dc:creator>
  <cp:lastModifiedBy>cc Zhang</cp:lastModifiedBy>
  <cp:revision>5</cp:revision>
  <dcterms:created xsi:type="dcterms:W3CDTF">2015-11-24T16:20:46Z</dcterms:created>
  <dcterms:modified xsi:type="dcterms:W3CDTF">2017-01-15T13:22:51Z</dcterms:modified>
</cp:coreProperties>
</file>